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C76AF-069F-4EBD-8B8A-B494586E76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F7E6E-355D-42FA-8B00-99AADD8509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8999D-A5E3-4105-B887-8052F1ED55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CA0D2-2B8F-4560-88A1-49E8853625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1A6AE-C9EB-4B2E-A7C4-A6D0AB4986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DD682-7D65-44A7-8015-391FB7CF0D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76BF2-94CE-4134-9606-40772DD862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7444F8-E8F5-4AC5-AC28-801647A823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CAF7A-EFDE-46F1-A85B-F83368CBD6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1D9D4-1969-4DEE-9754-8097159A3C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1747DE-27DF-4AE4-8774-0D13345DC3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A55970-A136-4BE2-AF66-F0B33FAF8C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184722-6C77-40FA-AD8F-64A169AA9008}" type="slidenum">
              <a:rPr b="0" lang="fi-FI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270000" y="2103480"/>
            <a:ext cx="8351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  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. Comparison of IFN-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IL-10 responses against MCV VP1 and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ndida albican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ng MCV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SV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MCV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–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SV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roup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55520" y="2770200"/>
          <a:ext cx="8785440" cy="1415880"/>
        </p:xfrm>
        <a:graphic>
          <a:graphicData uri="http://schemas.openxmlformats.org/drawingml/2006/table">
            <a:tbl>
              <a:tblPr/>
              <a:tblGrid>
                <a:gridCol w="2160720"/>
                <a:gridCol w="1008000"/>
                <a:gridCol w="934920"/>
                <a:gridCol w="1081080"/>
                <a:gridCol w="863640"/>
                <a:gridCol w="1440000"/>
                <a:gridCol w="1297080"/>
              </a:tblGrid>
              <a:tr h="547200">
                <a:tc>
                  <a:txBody>
                    <a:bodyPr lIns="46800" rIns="468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 VP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FN-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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g/mL±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 VP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-10 pg/mL±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ndid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FN-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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g/mL±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ndid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i-FI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-10 pg/mL±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7600">
                <a:tc>
                  <a:txBody>
                    <a:bodyPr lIns="46800" rIns="4680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tigen concentration ((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/m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0240">
                <a:tc>
                  <a:txBody>
                    <a:bodyPr lIns="46800" rIns="468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+TSV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0.0±168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0.0±173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0.0 ±144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.0±3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80.1±1790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7.5±289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240">
                <a:tc>
                  <a:txBody>
                    <a:bodyPr lIns="46800" rIns="468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 –TSV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.2±58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.5±45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.8 ±18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6±15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61.7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2324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5.4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544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240">
                <a:tc>
                  <a:txBody>
                    <a:bodyPr lIns="46800" rIns="468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0" rIns="468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6800" marR="46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Rectangle 6"/>
          <p:cNvSpPr/>
          <p:nvPr/>
        </p:nvSpPr>
        <p:spPr>
          <a:xfrm>
            <a:off x="103680" y="620640"/>
            <a:ext cx="206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6T16:58:40Z</dcterms:created>
  <dc:creator>lab16 arun kumar</dc:creator>
  <dc:description/>
  <dc:language>en-US</dc:language>
  <cp:lastModifiedBy>lab16 arun kumar</cp:lastModifiedBy>
  <dcterms:modified xsi:type="dcterms:W3CDTF">2012-07-06T17:00:33Z</dcterms:modified>
  <cp:revision>1</cp:revision>
  <dc:subject/>
  <dc:title>Slide 1</dc:title>
</cp:coreProperties>
</file>